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324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5" d="100"/>
          <a:sy n="65" d="100"/>
        </p:scale>
        <p:origin x="2453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altLang="ko-KR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944271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46772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61936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835683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ko-KR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231860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59630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ko-KR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ko-KR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978853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220615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83423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ko-KR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777741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altLang="ko-KR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ko-KR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544006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225703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384EAD4-1867-4E85-AA04-9E51B8B90905}"/>
              </a:ext>
            </a:extLst>
          </p:cNvPr>
          <p:cNvSpPr txBox="1"/>
          <p:nvPr/>
        </p:nvSpPr>
        <p:spPr>
          <a:xfrm>
            <a:off x="1" y="211014"/>
            <a:ext cx="67759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Data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. Promoter sequences for luciferase reporter assays</a:t>
            </a: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5CA1E660-321D-4294-B886-1D9B9ECA34D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62065340"/>
              </p:ext>
            </p:extLst>
          </p:nvPr>
        </p:nvGraphicFramePr>
        <p:xfrm>
          <a:off x="463061" y="847579"/>
          <a:ext cx="5931878" cy="383711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78877">
                  <a:extLst>
                    <a:ext uri="{9D8B030D-6E8A-4147-A177-3AD203B41FA5}">
                      <a16:colId xmlns:a16="http://schemas.microsoft.com/office/drawing/2014/main" val="1892548952"/>
                    </a:ext>
                  </a:extLst>
                </a:gridCol>
                <a:gridCol w="4953001">
                  <a:extLst>
                    <a:ext uri="{9D8B030D-6E8A-4147-A177-3AD203B41FA5}">
                      <a16:colId xmlns:a16="http://schemas.microsoft.com/office/drawing/2014/main" val="1951518647"/>
                    </a:ext>
                  </a:extLst>
                </a:gridCol>
              </a:tblGrid>
              <a:tr h="39575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ko-KR" sz="1100" u="non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moters</a:t>
                      </a:r>
                      <a:endParaRPr lang="ko-KR" sz="1100" u="non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u="non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Sequences</a:t>
                      </a:r>
                      <a:endParaRPr lang="ko-KR" sz="1100" u="non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2973727"/>
                  </a:ext>
                </a:extLst>
              </a:tr>
              <a:tr h="715609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u="non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HRE8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ko-KR" sz="1100" u="non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GAGCGGAGGGGAGACTGACCGGAGCGCGGATCGGGACAGCGGCCGGGACAGCGGCGAGACGC</a:t>
                      </a:r>
                      <a:r>
                        <a:rPr lang="en-US" altLang="ko-KR" sz="1100" b="1" u="none" kern="1200" dirty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CGTG</a:t>
                      </a:r>
                      <a:r>
                        <a:rPr lang="en-US" altLang="ko-KR" sz="1100" u="non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GTGAGCGCGCCGGACCAAGCGGGCCCAGAAGCGGGTGAGGAAC</a:t>
                      </a:r>
                      <a:endParaRPr lang="en-US" altLang="ko-KR" sz="1100" u="none" kern="1200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84754575"/>
                  </a:ext>
                </a:extLst>
              </a:tr>
              <a:tr h="715609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ko-KR" sz="1100" u="non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HRE8 mut</a:t>
                      </a:r>
                      <a:endParaRPr lang="ko-KR" sz="1100" u="non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ko-KR" sz="1100" u="non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GAGCGGAGGGGAGACTGACCGGAGCGCGGATCGGGACAGCGGCCGGGACAGCGGCGAGACGC</a:t>
                      </a:r>
                      <a:r>
                        <a:rPr lang="en-US" altLang="ko-KR" sz="1100" b="1" u="none" kern="12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GCAT</a:t>
                      </a:r>
                      <a:r>
                        <a:rPr lang="en-US" altLang="ko-KR" sz="1100" u="non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GTGAGCGCGCCGGACCAAGCGGGCCCAGAAGCGGGTGAGGAAC</a:t>
                      </a:r>
                      <a:endParaRPr lang="ko-KR" sz="1100" u="non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01105560"/>
                  </a:ext>
                </a:extLst>
              </a:tr>
              <a:tr h="626079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HRE9</a:t>
                      </a:r>
                      <a:endParaRPr lang="ko-KR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ko-KR" sz="1100" u="non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TGTGCTCCT</a:t>
                      </a:r>
                      <a:r>
                        <a:rPr lang="en-US" altLang="ko-KR" sz="1100" b="0" u="non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</a:t>
                      </a:r>
                      <a:r>
                        <a:rPr lang="en-US" altLang="ko-KR" sz="1100" b="1" u="none" kern="1200" dirty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GTG</a:t>
                      </a:r>
                      <a:r>
                        <a:rPr lang="en-US" altLang="ko-KR" sz="1100" u="non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CTCGGTGGGAACAGGCCCTGGCCCGGCGCCCGCGGGCGG</a:t>
                      </a:r>
                      <a:r>
                        <a:rPr lang="en-US" altLang="ko-KR" sz="1100" b="0" u="non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G</a:t>
                      </a:r>
                      <a:r>
                        <a:rPr lang="en-US" altLang="ko-KR" sz="1100" b="1" u="none" kern="1200" dirty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GTG</a:t>
                      </a:r>
                      <a:r>
                        <a:rPr lang="en-US" altLang="ko-KR" sz="1100" u="non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GCGGTTTGTTTACGTCCGAGGGCGG</a:t>
                      </a:r>
                      <a:r>
                        <a:rPr lang="en-US" altLang="ko-KR" sz="1100" b="1" u="none" kern="1200" dirty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CGTG</a:t>
                      </a:r>
                      <a:r>
                        <a:rPr lang="en-US" altLang="ko-KR" sz="1100" u="non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GTTCCCTGGCGGGCGGCCTGGGTATCCTGCCCGGTG</a:t>
                      </a:r>
                      <a:r>
                        <a:rPr lang="en-US" altLang="ko-KR" sz="1100" b="1" u="none" kern="1200" dirty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GTGCGTG</a:t>
                      </a:r>
                      <a:r>
                        <a:rPr lang="en-US" altLang="ko-KR" sz="1100" u="non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GCTGTGTACCTCGGGG</a:t>
                      </a:r>
                      <a:r>
                        <a:rPr lang="en-US" altLang="ko-KR" sz="1100" b="0" u="non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</a:t>
                      </a:r>
                      <a:r>
                        <a:rPr lang="en-US" altLang="ko-KR" sz="1100" b="1" u="none" kern="1200" dirty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GTG</a:t>
                      </a:r>
                      <a:r>
                        <a:rPr lang="en-US" altLang="ko-KR" sz="1100" u="non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GT</a:t>
                      </a:r>
                      <a:r>
                        <a:rPr lang="en-US" altLang="ko-KR" sz="1100" b="0" u="non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</a:t>
                      </a:r>
                      <a:r>
                        <a:rPr lang="en-US" altLang="ko-KR" sz="1100" b="1" u="none" kern="1200" dirty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GTG</a:t>
                      </a:r>
                      <a:r>
                        <a:rPr lang="en-US" altLang="ko-KR" sz="1100" u="non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GTTGTGCTTGTGTGTGC</a:t>
                      </a:r>
                      <a:endParaRPr lang="ko-KR" sz="1100" u="non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53532290"/>
                  </a:ext>
                </a:extLst>
              </a:tr>
              <a:tr h="804858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HRE9 mut</a:t>
                      </a:r>
                      <a:endParaRPr lang="ko-KR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ko-KR" sz="1100" u="non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TGTGCTCCT</a:t>
                      </a:r>
                      <a:r>
                        <a:rPr lang="en-US" altLang="ko-KR" sz="1100" b="0" u="non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</a:t>
                      </a:r>
                      <a:r>
                        <a:rPr lang="en-US" altLang="ko-KR" sz="1100" b="1" u="none" kern="12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AAT</a:t>
                      </a:r>
                      <a:r>
                        <a:rPr lang="en-US" altLang="ko-KR" sz="1100" u="non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CTCGGTGGGAACAGGCCCTGGCCCGGCGCCCGCGGGCGG</a:t>
                      </a:r>
                      <a:r>
                        <a:rPr lang="en-US" altLang="ko-KR" sz="1100" b="0" u="non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G</a:t>
                      </a:r>
                      <a:r>
                        <a:rPr lang="en-US" altLang="ko-KR" sz="1100" b="1" u="none" kern="12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AAT</a:t>
                      </a:r>
                      <a:r>
                        <a:rPr lang="en-US" altLang="ko-KR" sz="1100" u="non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GCGGTTTGTTTACGTCCGAGGGCGG</a:t>
                      </a:r>
                      <a:r>
                        <a:rPr lang="en-US" altLang="ko-KR" sz="1100" b="1" u="none" kern="12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TAAT</a:t>
                      </a:r>
                      <a:r>
                        <a:rPr lang="en-US" altLang="ko-KR" sz="1100" u="non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GTTCCCTGGCGGGCGGCCTGGGTATCCTGCCCGGTG</a:t>
                      </a:r>
                      <a:r>
                        <a:rPr lang="en-US" altLang="ko-KR" sz="1100" b="1" u="none" kern="12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AATTAAT</a:t>
                      </a:r>
                      <a:r>
                        <a:rPr lang="en-US" altLang="ko-KR" sz="1100" u="non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GCTGTGTACCTCGG</a:t>
                      </a:r>
                      <a:r>
                        <a:rPr lang="en-US" altLang="ko-KR" sz="1100" b="0" u="non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</a:t>
                      </a:r>
                      <a:r>
                        <a:rPr lang="en-US" altLang="ko-KR" sz="1100" b="0" u="none" kern="12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</a:t>
                      </a:r>
                      <a:r>
                        <a:rPr lang="en-US" altLang="ko-KR" sz="1100" b="1" u="none" kern="12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AATT</a:t>
                      </a:r>
                      <a:r>
                        <a:rPr lang="en-US" altLang="ko-KR" sz="1100" u="non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TG</a:t>
                      </a:r>
                      <a:r>
                        <a:rPr lang="en-US" altLang="ko-KR" sz="1100" b="1" u="none" kern="12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AAT</a:t>
                      </a:r>
                      <a:r>
                        <a:rPr lang="en-US" altLang="ko-KR" sz="1100" b="0" u="non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</a:t>
                      </a:r>
                      <a:r>
                        <a:rPr lang="en-US" altLang="ko-KR" sz="1100" u="non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TTGTGCTTGTGTGTGC</a:t>
                      </a:r>
                      <a:endParaRPr lang="ko-KR" sz="1100" u="non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2348187"/>
                  </a:ext>
                </a:extLst>
              </a:tr>
              <a:tr h="534726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IL11 promoter</a:t>
                      </a:r>
                      <a:endParaRPr lang="ko-KR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altLang="ko-KR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GTCCCTGATGTGTTCAGAAAAGTTAACGAGGGGAATAAGGATGGTCAGCACTGACTTTGTGCTTCACGTGAA</a:t>
                      </a:r>
                      <a:r>
                        <a:rPr lang="en-US" altLang="ko-KR" sz="1100" b="1" u="sng" kern="1200" dirty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GAG</a:t>
                      </a:r>
                      <a:r>
                        <a:rPr lang="en-US" altLang="ko-KR" sz="1100" b="1" kern="1200" dirty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TC</a:t>
                      </a:r>
                      <a:r>
                        <a:rPr lang="en-US" altLang="ko-KR" sz="1100" b="1" u="sng" kern="1200" dirty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C</a:t>
                      </a:r>
                      <a:r>
                        <a:rPr lang="en-US" altLang="ko-KR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TTATCCTCATCGTGG</a:t>
                      </a:r>
                      <a:endParaRPr lang="ko-KR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8212129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840918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5</TotalTime>
  <Words>25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jung Moon</dc:creator>
  <cp:lastModifiedBy>Moon Ejung</cp:lastModifiedBy>
  <cp:revision>23</cp:revision>
  <cp:lastPrinted>2018-12-27T23:59:30Z</cp:lastPrinted>
  <dcterms:created xsi:type="dcterms:W3CDTF">2018-12-27T23:58:40Z</dcterms:created>
  <dcterms:modified xsi:type="dcterms:W3CDTF">2021-05-20T15:25:09Z</dcterms:modified>
</cp:coreProperties>
</file>